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570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k99\Desktop\YR%20PLOS%20One%20paper\Files%20for%20Resubmission\GO%20analysis%208-5-2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k99\Desktop\YR%20PLOS%20One%20paper\Files%20for%20Resubmission\GO%20analysis%208-5-2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/>
              <a:t>GO Analysis</a:t>
            </a:r>
            <a:r>
              <a:rPr lang="en-US" altLang="zh-CN" baseline="0"/>
              <a:t> for down-regulated genes</a:t>
            </a:r>
            <a:endParaRPr lang="en-US" altLang="zh-CN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Down_regulated_gene!$B$53:$B$62</c:f>
              <c:strCache>
                <c:ptCount val="10"/>
                <c:pt idx="0">
                  <c:v>GO:0001958~endochondral ossification</c:v>
                </c:pt>
                <c:pt idx="1">
                  <c:v>GO:0043410~positive regulation of MAPK cascade</c:v>
                </c:pt>
                <c:pt idx="2">
                  <c:v>GO:0030522~intracellular receptor signaling pathway</c:v>
                </c:pt>
                <c:pt idx="3">
                  <c:v>GO:0048714~positive regulation of oligodendrocyte differentiation</c:v>
                </c:pt>
                <c:pt idx="4">
                  <c:v>GO:0045893~positive regulation of DNA-templated transcription</c:v>
                </c:pt>
                <c:pt idx="5">
                  <c:v>GO:0010977~negative regulation of neuron projection development</c:v>
                </c:pt>
                <c:pt idx="6">
                  <c:v>GO:0072089~stem cell proliferation</c:v>
                </c:pt>
                <c:pt idx="7">
                  <c:v>GO:0007165~signal transduction</c:v>
                </c:pt>
                <c:pt idx="8">
                  <c:v>GO:0022008~neurogenesis</c:v>
                </c:pt>
                <c:pt idx="9">
                  <c:v>GO:0010628~positive regulation of gene expression</c:v>
                </c:pt>
              </c:strCache>
            </c:strRef>
          </c:cat>
          <c:val>
            <c:numRef>
              <c:f>Down_regulated_gene!$N$53:$N$62</c:f>
              <c:numCache>
                <c:formatCode>General</c:formatCode>
                <c:ptCount val="10"/>
                <c:pt idx="0">
                  <c:v>2.1905306807784704</c:v>
                </c:pt>
                <c:pt idx="1">
                  <c:v>2.2261226901306452</c:v>
                </c:pt>
                <c:pt idx="2">
                  <c:v>2.2420328554969617</c:v>
                </c:pt>
                <c:pt idx="3">
                  <c:v>2.3260180812318216</c:v>
                </c:pt>
                <c:pt idx="4">
                  <c:v>2.4378007241733459</c:v>
                </c:pt>
                <c:pt idx="5">
                  <c:v>2.7244866927228402</c:v>
                </c:pt>
                <c:pt idx="6">
                  <c:v>3.0807285861379956</c:v>
                </c:pt>
                <c:pt idx="7">
                  <c:v>3.220976716368678</c:v>
                </c:pt>
                <c:pt idx="8">
                  <c:v>3.6284788173147158</c:v>
                </c:pt>
                <c:pt idx="9">
                  <c:v>5.08703727203185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F1-402B-83AF-A88BA9AF3B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121203248"/>
        <c:axId val="1121190288"/>
      </c:barChart>
      <c:catAx>
        <c:axId val="11212032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21190288"/>
        <c:crosses val="autoZero"/>
        <c:auto val="1"/>
        <c:lblAlgn val="ctr"/>
        <c:lblOffset val="100"/>
        <c:noMultiLvlLbl val="0"/>
      </c:catAx>
      <c:valAx>
        <c:axId val="11211902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-log10(pvalu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21203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</a:rPr>
              <a:t>GO Analysis for up-regulated genes</a:t>
            </a:r>
            <a:r>
              <a:rPr lang="en-US" altLang="zh-CN"/>
              <a:t>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GO analysis 8-5-25.xlsx]Up_regulated_gene'!$B$70,'[GO analysis 8-5-25.xlsx]Up_regulated_gene'!$B$71,'[GO analysis 8-5-25.xlsx]Up_regulated_gene'!$B$72,'[GO analysis 8-5-25.xlsx]Up_regulated_gene'!$B$73,'[GO analysis 8-5-25.xlsx]Up_regulated_gene'!$B$74,'[GO analysis 8-5-25.xlsx]Up_regulated_gene'!$B$75,'[GO analysis 8-5-25.xlsx]Up_regulated_gene'!$B$76,'[GO analysis 8-5-25.xlsx]Up_regulated_gene'!$B$77,'[GO analysis 8-5-25.xlsx]Up_regulated_gene'!$B$78,'[GO analysis 8-5-25.xlsx]Up_regulated_gene'!$B$79</c:f>
              <c:strCache>
                <c:ptCount val="10"/>
                <c:pt idx="0">
                  <c:v>GO:0071277~cellular response to calcium ion</c:v>
                </c:pt>
                <c:pt idx="1">
                  <c:v>GO:0045071~negative regulation of viral genome replication</c:v>
                </c:pt>
                <c:pt idx="2">
                  <c:v>GO:0071376~cellular response to corticotropin-releasing hormone stimulus</c:v>
                </c:pt>
                <c:pt idx="3">
                  <c:v>GO:0030198~extracellular matrix organization</c:v>
                </c:pt>
                <c:pt idx="4">
                  <c:v>GO:0009612~response to mechanical stimulus</c:v>
                </c:pt>
                <c:pt idx="5">
                  <c:v>GO:0045087~innate immune response</c:v>
                </c:pt>
                <c:pt idx="6">
                  <c:v>GO:0007155~cell adhesion</c:v>
                </c:pt>
                <c:pt idx="7">
                  <c:v>GO:0140374~antiviral innate immune response</c:v>
                </c:pt>
                <c:pt idx="8">
                  <c:v>GO:0009615~response to virus</c:v>
                </c:pt>
                <c:pt idx="9">
                  <c:v>GO:0051607~defense response to virus</c:v>
                </c:pt>
              </c:strCache>
            </c:strRef>
          </c:cat>
          <c:val>
            <c:numRef>
              <c:f>'[GO analysis 8-5-25.xlsx]Up_regulated_gene'!$N$70,'[GO analysis 8-5-25.xlsx]Up_regulated_gene'!$N$71,'[GO analysis 8-5-25.xlsx]Up_regulated_gene'!$N$72,'[GO analysis 8-5-25.xlsx]Up_regulated_gene'!$N$73,'[GO analysis 8-5-25.xlsx]Up_regulated_gene'!$N$74,'[GO analysis 8-5-25.xlsx]Up_regulated_gene'!$N$75,'[GO analysis 8-5-25.xlsx]Up_regulated_gene'!$N$76,'[GO analysis 8-5-25.xlsx]Up_regulated_gene'!$N$77,'[GO analysis 8-5-25.xlsx]Up_regulated_gene'!$N$78,'[GO analysis 8-5-25.xlsx]Up_regulated_gene'!$N$79</c:f>
              <c:numCache>
                <c:formatCode>General</c:formatCode>
                <c:ptCount val="10"/>
                <c:pt idx="0">
                  <c:v>2.4233578083502656</c:v>
                </c:pt>
                <c:pt idx="1">
                  <c:v>2.5697180372147068</c:v>
                </c:pt>
                <c:pt idx="2">
                  <c:v>2.7689686854784723</c:v>
                </c:pt>
                <c:pt idx="3">
                  <c:v>2.8029186106638209</c:v>
                </c:pt>
                <c:pt idx="4">
                  <c:v>3.0284848665033492</c:v>
                </c:pt>
                <c:pt idx="5">
                  <c:v>3.200880665849263</c:v>
                </c:pt>
                <c:pt idx="6">
                  <c:v>3.3089369318655955</c:v>
                </c:pt>
                <c:pt idx="7">
                  <c:v>3.659833237857995</c:v>
                </c:pt>
                <c:pt idx="8">
                  <c:v>4.7376422830005938</c:v>
                </c:pt>
                <c:pt idx="9">
                  <c:v>5.36275605091965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70F-4A7D-A795-BC94C0493C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04855568"/>
        <c:axId val="604856048"/>
      </c:barChart>
      <c:catAx>
        <c:axId val="60485556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4856048"/>
        <c:crosses val="autoZero"/>
        <c:auto val="1"/>
        <c:lblAlgn val="ctr"/>
        <c:lblOffset val="100"/>
        <c:noMultiLvlLbl val="0"/>
      </c:catAx>
      <c:valAx>
        <c:axId val="6048560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-log10(pvalu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4855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27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003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835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368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937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840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441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294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641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097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4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078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AA4E9077-25C4-EE25-F118-E522FBA6FC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6067550"/>
              </p:ext>
            </p:extLst>
          </p:nvPr>
        </p:nvGraphicFramePr>
        <p:xfrm>
          <a:off x="980598" y="3694112"/>
          <a:ext cx="6878003" cy="2771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9C2BF747-7113-5F74-3A1D-AF637A2631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8201629"/>
              </p:ext>
            </p:extLst>
          </p:nvPr>
        </p:nvGraphicFramePr>
        <p:xfrm>
          <a:off x="1058934" y="800244"/>
          <a:ext cx="7127732" cy="27302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1D5AFA0-84F1-4094-95FB-0361C483300A}"/>
              </a:ext>
            </a:extLst>
          </p:cNvPr>
          <p:cNvSpPr txBox="1"/>
          <p:nvPr/>
        </p:nvSpPr>
        <p:spPr>
          <a:xfrm>
            <a:off x="1651668" y="163611"/>
            <a:ext cx="7327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2 Fig. GO Analysis of STAG2-Regulated Gene Expression</a:t>
            </a:r>
          </a:p>
        </p:txBody>
      </p:sp>
    </p:spTree>
    <p:extLst>
      <p:ext uri="{BB962C8B-B14F-4D97-AF65-F5344CB8AC3E}">
        <p14:creationId xmlns:p14="http://schemas.microsoft.com/office/powerpoint/2010/main" val="23723236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6</TotalTime>
  <Words>29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gSik Kim</dc:creator>
  <cp:lastModifiedBy>JungSik Kim</cp:lastModifiedBy>
  <cp:revision>6</cp:revision>
  <dcterms:created xsi:type="dcterms:W3CDTF">2025-08-06T12:41:52Z</dcterms:created>
  <dcterms:modified xsi:type="dcterms:W3CDTF">2025-08-15T12:36:34Z</dcterms:modified>
</cp:coreProperties>
</file>